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979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F4579-20EE-41A5-BD15-5D75455DBA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DE37C-31E5-4402-B731-17B3FDC49D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B9AAC5-1C50-428C-A400-817E76E3BB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11A6B-D358-4B44-9AB0-C0CCDF50ED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55848-9EAC-4ED9-956F-235C1BD326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68F68-3189-477F-8DB7-CB48E8B5E7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F295C-6C75-48C6-8024-634021CB2B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A1126C-B061-44F7-AC6A-565A0856DE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D0CAB-372F-4E65-A643-23D8C2A471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E0495-8846-48D5-84BD-FB0A6ECC6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FB79F-5AC6-48D5-9AA3-DA1110BEAA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74AA0-BD29-4A21-A1C7-16A61D435F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D1BB4F-1FE7-440E-9648-D8E3B5E42A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304920" y="457200"/>
            <a:ext cx="6019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2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231480" y="1143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2" descr=""/>
          <p:cNvPicPr/>
          <p:nvPr/>
        </p:nvPicPr>
        <p:blipFill>
          <a:blip r:embed="rId1"/>
          <a:srcRect l="10783" t="17847" r="13176" b="36714"/>
          <a:stretch/>
        </p:blipFill>
        <p:spPr>
          <a:xfrm>
            <a:off x="1523880" y="1085760"/>
            <a:ext cx="3694320" cy="213372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>
            <a:off x="920880" y="3184560"/>
            <a:ext cx="1052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3C (5 mg/k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3C (10 mg/kg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3C (20 mg/k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1943640" y="3186000"/>
            <a:ext cx="2509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2302560" y="3186000"/>
            <a:ext cx="2858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2746080" y="3186000"/>
            <a:ext cx="324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3"/>
          <p:cNvSpPr/>
          <p:nvPr/>
        </p:nvSpPr>
        <p:spPr>
          <a:xfrm>
            <a:off x="2666880" y="898560"/>
            <a:ext cx="83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or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 mg/k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4"/>
          <p:cNvSpPr/>
          <p:nvPr/>
        </p:nvSpPr>
        <p:spPr>
          <a:xfrm>
            <a:off x="3657600" y="8985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or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5 mg/k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21"/>
          <p:cNvSpPr/>
          <p:nvPr/>
        </p:nvSpPr>
        <p:spPr>
          <a:xfrm>
            <a:off x="2286000" y="1203480"/>
            <a:ext cx="1554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22"/>
          <p:cNvSpPr/>
          <p:nvPr/>
        </p:nvSpPr>
        <p:spPr>
          <a:xfrm>
            <a:off x="3916440" y="1201680"/>
            <a:ext cx="2746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"/>
          <p:cNvSpPr/>
          <p:nvPr/>
        </p:nvSpPr>
        <p:spPr>
          <a:xfrm rot="16200000">
            <a:off x="615600" y="2009520"/>
            <a:ext cx="140904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tive tumor grow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7"/>
          <p:cNvSpPr/>
          <p:nvPr/>
        </p:nvSpPr>
        <p:spPr>
          <a:xfrm>
            <a:off x="3178080" y="3186000"/>
            <a:ext cx="324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8"/>
          <p:cNvSpPr/>
          <p:nvPr/>
        </p:nvSpPr>
        <p:spPr>
          <a:xfrm>
            <a:off x="4397040" y="3186000"/>
            <a:ext cx="324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9"/>
          <p:cNvSpPr/>
          <p:nvPr/>
        </p:nvSpPr>
        <p:spPr>
          <a:xfrm>
            <a:off x="3584520" y="3186000"/>
            <a:ext cx="324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40"/>
          <p:cNvSpPr/>
          <p:nvPr/>
        </p:nvSpPr>
        <p:spPr>
          <a:xfrm>
            <a:off x="3939840" y="3186000"/>
            <a:ext cx="324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6"/>
          <p:cNvSpPr/>
          <p:nvPr/>
        </p:nvSpPr>
        <p:spPr>
          <a:xfrm>
            <a:off x="231480" y="39466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" descr="C:\Documents and Settings\taylorb\Desktop\CycE manuscript\Mice data from HA_062011\Control +velcade mice-2.jpg"/>
          <p:cNvPicPr/>
          <p:nvPr/>
        </p:nvPicPr>
        <p:blipFill>
          <a:blip r:embed="rId2">
            <a:lum bright="30000"/>
          </a:blip>
          <a:srcRect l="2065" t="34862" r="5504" b="21049"/>
          <a:stretch/>
        </p:blipFill>
        <p:spPr>
          <a:xfrm>
            <a:off x="750960" y="4330800"/>
            <a:ext cx="5573520" cy="199368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41"/>
          <p:cNvSpPr/>
          <p:nvPr/>
        </p:nvSpPr>
        <p:spPr>
          <a:xfrm>
            <a:off x="990720" y="4073400"/>
            <a:ext cx="1095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2"/>
          <p:cNvSpPr/>
          <p:nvPr/>
        </p:nvSpPr>
        <p:spPr>
          <a:xfrm>
            <a:off x="1876320" y="4073400"/>
            <a:ext cx="1095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5"/>
          <p:cNvSpPr/>
          <p:nvPr/>
        </p:nvSpPr>
        <p:spPr>
          <a:xfrm>
            <a:off x="2714760" y="3949560"/>
            <a:ext cx="109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5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6"/>
          <p:cNvSpPr/>
          <p:nvPr/>
        </p:nvSpPr>
        <p:spPr>
          <a:xfrm>
            <a:off x="3581280" y="3949560"/>
            <a:ext cx="10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10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7"/>
          <p:cNvSpPr/>
          <p:nvPr/>
        </p:nvSpPr>
        <p:spPr>
          <a:xfrm>
            <a:off x="4467240" y="3949560"/>
            <a:ext cx="10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20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8"/>
          <p:cNvSpPr/>
          <p:nvPr/>
        </p:nvSpPr>
        <p:spPr>
          <a:xfrm>
            <a:off x="5257800" y="394956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20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0.5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Chart 50" descr=""/>
          <p:cNvPicPr/>
          <p:nvPr/>
        </p:nvPicPr>
        <p:blipFill>
          <a:blip r:embed="rId3"/>
          <a:stretch/>
        </p:blipFill>
        <p:spPr>
          <a:xfrm>
            <a:off x="530280" y="7156440"/>
            <a:ext cx="5797440" cy="1463760"/>
          </a:xfrm>
          <a:prstGeom prst="rect">
            <a:avLst/>
          </a:prstGeom>
          <a:ln w="0">
            <a:noFill/>
          </a:ln>
        </p:spPr>
      </p:pic>
      <p:sp>
        <p:nvSpPr>
          <p:cNvPr id="66" name="Text Box 2"/>
          <p:cNvSpPr/>
          <p:nvPr/>
        </p:nvSpPr>
        <p:spPr>
          <a:xfrm rot="16200000">
            <a:off x="-70200" y="7724880"/>
            <a:ext cx="133956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umor weight (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6"/>
          <p:cNvSpPr/>
          <p:nvPr/>
        </p:nvSpPr>
        <p:spPr>
          <a:xfrm>
            <a:off x="231480" y="7086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8"/>
          <p:cNvSpPr/>
          <p:nvPr/>
        </p:nvSpPr>
        <p:spPr>
          <a:xfrm>
            <a:off x="990720" y="8672400"/>
            <a:ext cx="1095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9"/>
          <p:cNvSpPr/>
          <p:nvPr/>
        </p:nvSpPr>
        <p:spPr>
          <a:xfrm>
            <a:off x="1876320" y="8672400"/>
            <a:ext cx="1095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0"/>
          <p:cNvSpPr/>
          <p:nvPr/>
        </p:nvSpPr>
        <p:spPr>
          <a:xfrm>
            <a:off x="2714760" y="8548560"/>
            <a:ext cx="109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5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1"/>
          <p:cNvSpPr/>
          <p:nvPr/>
        </p:nvSpPr>
        <p:spPr>
          <a:xfrm>
            <a:off x="3581280" y="8548560"/>
            <a:ext cx="10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10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2"/>
          <p:cNvSpPr/>
          <p:nvPr/>
        </p:nvSpPr>
        <p:spPr>
          <a:xfrm>
            <a:off x="4467240" y="8548560"/>
            <a:ext cx="10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20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1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3"/>
          <p:cNvSpPr/>
          <p:nvPr/>
        </p:nvSpPr>
        <p:spPr>
          <a:xfrm>
            <a:off x="5257800" y="854856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3C 20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ort 0.5 mg/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4"/>
          <p:cNvSpPr/>
          <p:nvPr/>
        </p:nvSpPr>
        <p:spPr>
          <a:xfrm>
            <a:off x="5185080" y="1157400"/>
            <a:ext cx="581400" cy="77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 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 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 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6" descr="C:\Documents and Settings\taylorb\Desktop\CycE manuscript\Mice data from HA_062011\Fig of x6 I3C_Velc tumors alone_v3_CROPPED.tif"/>
          <p:cNvPicPr/>
          <p:nvPr/>
        </p:nvPicPr>
        <p:blipFill>
          <a:blip r:embed="rId4">
            <a:lum bright="20000"/>
          </a:blip>
          <a:srcRect l="2345" t="51244" r="2031" b="2981"/>
          <a:stretch/>
        </p:blipFill>
        <p:spPr>
          <a:xfrm>
            <a:off x="746280" y="6338880"/>
            <a:ext cx="5592600" cy="70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4T22:01:57Z</dcterms:created>
  <dc:creator>cshs</dc:creator>
  <dc:description/>
  <dc:language>en-US</dc:language>
  <cp:lastModifiedBy>shamantha</cp:lastModifiedBy>
  <dcterms:modified xsi:type="dcterms:W3CDTF">2011-12-03T16:36:00Z</dcterms:modified>
  <cp:revision>901</cp:revision>
  <dc:subject/>
  <dc:title>Slide 1</dc:title>
</cp:coreProperties>
</file>